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84058-4AC8-42F3-873C-447A3720EF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4F122-376B-46BA-A721-4B4718186B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127F38-5834-4E6D-8B7F-3CCC4A8B48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93209-88A1-404D-B187-416A04B3A7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487D2-8E5E-4F19-8E6A-9B9CFD3E15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DFAC9-48A3-400F-B9A2-30B60B05C1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078D9-05CD-4372-AF37-2844E9BDA4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DF79D-9BD2-4FEA-A741-C81FCB39B6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1A359-3FF5-4FEA-8580-D4DC62D934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7F748E-DD5E-4B40-B90C-F224D919D4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17F02E-2C40-4D45-A417-993616BD1B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0E9FB-7F3D-4182-B104-70AF36910D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2E2C75-9B46-44F9-954D-B86719FAC13D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4645080" y="695160"/>
            <a:ext cx="3460680" cy="31896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" descr=""/>
          <p:cNvPicPr/>
          <p:nvPr/>
        </p:nvPicPr>
        <p:blipFill>
          <a:blip r:embed="rId2"/>
          <a:stretch/>
        </p:blipFill>
        <p:spPr>
          <a:xfrm>
            <a:off x="879480" y="711360"/>
            <a:ext cx="3297240" cy="3157200"/>
          </a:xfrm>
          <a:prstGeom prst="rect">
            <a:avLst/>
          </a:prstGeom>
          <a:ln w="0">
            <a:noFill/>
          </a:ln>
        </p:spPr>
      </p:pic>
      <p:sp>
        <p:nvSpPr>
          <p:cNvPr id="43" name="TextBox 9"/>
          <p:cNvSpPr/>
          <p:nvPr/>
        </p:nvSpPr>
        <p:spPr>
          <a:xfrm>
            <a:off x="788400" y="576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0"/>
          <p:cNvSpPr/>
          <p:nvPr/>
        </p:nvSpPr>
        <p:spPr>
          <a:xfrm>
            <a:off x="4683960" y="5716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1"/>
          <p:cNvSpPr/>
          <p:nvPr/>
        </p:nvSpPr>
        <p:spPr>
          <a:xfrm>
            <a:off x="15840" y="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3"/>
          <p:cNvSpPr/>
          <p:nvPr/>
        </p:nvSpPr>
        <p:spPr>
          <a:xfrm>
            <a:off x="-23040" y="12600"/>
            <a:ext cx="232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ementary Tabl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1403280" y="512640"/>
          <a:ext cx="6096240" cy="1857600"/>
        </p:xfrm>
        <a:graphic>
          <a:graphicData uri="http://schemas.openxmlformats.org/drawingml/2006/table">
            <a:tbl>
              <a:tblPr/>
              <a:tblGrid>
                <a:gridCol w="968400"/>
                <a:gridCol w="792360"/>
                <a:gridCol w="593640"/>
                <a:gridCol w="528480"/>
                <a:gridCol w="571680"/>
                <a:gridCol w="528480"/>
                <a:gridCol w="528840"/>
                <a:gridCol w="527040"/>
                <a:gridCol w="528480"/>
                <a:gridCol w="528840"/>
              </a:tblGrid>
              <a:tr h="668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variates influencing probability estimate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gnificant variables  p =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erall statistical significance of the model 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tients included in analysis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gelkerke R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ses correctly identified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ecificity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nsitivity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itive predictive power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gative predictive power</a:t>
                      </a: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49040">
                <a:tc>
                  <a:txBody>
                    <a:bodyPr lIns="8280" rIns="8280" tIns="82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tio(cat)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rowSpan="8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= 0.0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rowSpan="8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 / 1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rowSpan="8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.3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rowSpan="8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.6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rowSpan="8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4.3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rowSpan="8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0.4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rowSpan="8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.9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rowSpan="8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.5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8280" rIns="8280" tIns="82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de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9400">
                <a:tc>
                  <a:txBody>
                    <a:bodyPr lIns="8280" rIns="8280" tIns="82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umour size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7600">
                <a:tc>
                  <a:txBody>
                    <a:bodyPr lIns="8280" rIns="8280" tIns="82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scular invas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280" rIns="8280" tIns="828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9400">
                <a:tc>
                  <a:txBody>
                    <a:bodyPr lIns="8280" rIns="8280" tIns="82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ymph node (cat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280" rIns="8280" tIns="828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9040">
                <a:tc>
                  <a:txBody>
                    <a:bodyPr lIns="8280" rIns="8280" tIns="82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R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280" rIns="8280" tIns="828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7600">
                <a:tc>
                  <a:txBody>
                    <a:bodyPr lIns="8280" rIns="8280" tIns="82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280" rIns="8280" tIns="828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9400">
                <a:tc>
                  <a:txBody>
                    <a:bodyPr lIns="8280" rIns="8280" tIns="82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ER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280" rIns="8280" tIns="828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 </a:t>
                      </a: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8280" marR="82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24T12:54:00Z</dcterms:created>
  <dc:creator>frysi</dc:creator>
  <dc:description/>
  <dc:language>en-US</dc:language>
  <cp:lastModifiedBy>ravikumar.n</cp:lastModifiedBy>
  <cp:lastPrinted>2014-04-03T13:41:01Z</cp:lastPrinted>
  <dcterms:modified xsi:type="dcterms:W3CDTF">2016-03-19T13:38:34Z</dcterms:modified>
  <cp:revision>9</cp:revision>
  <dc:subject/>
  <dc:title>Slide 1</dc:title>
</cp:coreProperties>
</file>